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97" r:id="rId2"/>
    <p:sldId id="27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69"/>
    <p:restoredTop sz="83282"/>
  </p:normalViewPr>
  <p:slideViewPr>
    <p:cSldViewPr snapToGrid="0">
      <p:cViewPr>
        <p:scale>
          <a:sx n="144" d="100"/>
          <a:sy n="144" d="100"/>
        </p:scale>
        <p:origin x="2560" y="-1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815C4B-290A-FB49-ADEE-0A4D60D14A2D}" type="datetimeFigureOut">
              <a:rPr lang="en-US" smtClean="0"/>
              <a:t>8/24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C42E19-1F9B-5049-B6A5-48F2FF964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3438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B0C1DE-67B7-9EE8-53DB-E6B578892BF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B73B4D59-C52C-C51C-A7FF-C6B002C5579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E561AF0-33C1-2D77-A8F6-7D3BC899C84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51E5B7-A4FC-4D33-BECB-3E85470DACF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1D8E7C-204A-5542-8748-D9B9D48D171E}" type="slidenum">
              <a:rPr lang="de-CH" smtClean="0"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941561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C42E19-1F9B-5049-B6A5-48F2FF96487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497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65199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21358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70100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37179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76459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17649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8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64333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15903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34933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431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43049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8632FD-C224-9C4F-804A-97FCD0DCE4DD}" type="datetimeFigureOut">
              <a:rPr lang="de-CH" smtClean="0"/>
              <a:t>24.08.2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1935B-45A7-5146-9E67-6AEE5E8D8BA2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93626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AE05E1C-2603-3482-7FA0-A24A7B0CF4F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8A645DF-A78B-500C-CADA-21144637A1A8}"/>
              </a:ext>
            </a:extLst>
          </p:cNvPr>
          <p:cNvSpPr txBox="1"/>
          <p:nvPr/>
        </p:nvSpPr>
        <p:spPr>
          <a:xfrm>
            <a:off x="612318" y="735208"/>
            <a:ext cx="4959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6F08DA2C-C3A3-3EF8-EBC8-5FA1BD47079E}"/>
              </a:ext>
            </a:extLst>
          </p:cNvPr>
          <p:cNvGrpSpPr/>
          <p:nvPr/>
        </p:nvGrpSpPr>
        <p:grpSpPr>
          <a:xfrm>
            <a:off x="619748" y="1175516"/>
            <a:ext cx="4951973" cy="9132187"/>
            <a:chOff x="619748" y="1099316"/>
            <a:chExt cx="4951973" cy="9132187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861118F0-FDCD-F0E3-695A-0E392699BA84}"/>
                </a:ext>
              </a:extLst>
            </p:cNvPr>
            <p:cNvGrpSpPr/>
            <p:nvPr/>
          </p:nvGrpSpPr>
          <p:grpSpPr>
            <a:xfrm>
              <a:off x="689465" y="1176975"/>
              <a:ext cx="3545608" cy="2774710"/>
              <a:chOff x="689465" y="1176975"/>
              <a:chExt cx="3545608" cy="277471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30CEB1A-0432-9E6B-F44A-327500F2EF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45865" y="1176975"/>
                <a:ext cx="2989208" cy="2743200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1AF7692F-A63C-C306-F537-0DEB6471B2C5}"/>
                  </a:ext>
                </a:extLst>
              </p:cNvPr>
              <p:cNvSpPr txBox="1"/>
              <p:nvPr/>
            </p:nvSpPr>
            <p:spPr>
              <a:xfrm>
                <a:off x="1777941" y="3705464"/>
                <a:ext cx="207941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			diseased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5E8A2CE-27F2-772C-ABCF-BA4B5CA20605}"/>
                  </a:ext>
                </a:extLst>
              </p:cNvPr>
              <p:cNvSpPr txBox="1"/>
              <p:nvPr/>
            </p:nvSpPr>
            <p:spPr>
              <a:xfrm rot="16200000">
                <a:off x="-56893" y="2389829"/>
                <a:ext cx="1892825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ity of hyperreflective regions (n/mm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 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CF77E12-35A2-5899-C3C4-B47CA12CBCD5}"/>
                  </a:ext>
                </a:extLst>
              </p:cNvPr>
              <p:cNvSpPr txBox="1"/>
              <p:nvPr/>
            </p:nvSpPr>
            <p:spPr>
              <a:xfrm>
                <a:off x="1047669" y="1732967"/>
                <a:ext cx="377091" cy="189282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EDECB56B-3AFC-44CD-6E57-8296DA5C4505}"/>
                </a:ext>
              </a:extLst>
            </p:cNvPr>
            <p:cNvGrpSpPr/>
            <p:nvPr/>
          </p:nvGrpSpPr>
          <p:grpSpPr>
            <a:xfrm>
              <a:off x="689465" y="4332639"/>
              <a:ext cx="3545608" cy="2764766"/>
              <a:chOff x="689465" y="4332639"/>
              <a:chExt cx="3545608" cy="2764766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F084875-EEB2-5943-1676-605760C457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245865" y="4332639"/>
                <a:ext cx="2989208" cy="2743200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EDC52A4-B1D5-86EE-E396-DC7AA280202F}"/>
                  </a:ext>
                </a:extLst>
              </p:cNvPr>
              <p:cNvSpPr txBox="1"/>
              <p:nvPr/>
            </p:nvSpPr>
            <p:spPr>
              <a:xfrm>
                <a:off x="1777941" y="6851184"/>
                <a:ext cx="207941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			diseased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E2B2355-F1E8-3AED-D59E-B4DCCF501DD2}"/>
                  </a:ext>
                </a:extLst>
              </p:cNvPr>
              <p:cNvSpPr txBox="1"/>
              <p:nvPr/>
            </p:nvSpPr>
            <p:spPr>
              <a:xfrm rot="16200000">
                <a:off x="-149227" y="5474724"/>
                <a:ext cx="2077493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ity of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yporeflective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regions (n/mm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 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DC12D1C-46AF-65EA-B99A-F13B869A861C}"/>
                  </a:ext>
                </a:extLst>
              </p:cNvPr>
              <p:cNvSpPr txBox="1"/>
              <p:nvPr/>
            </p:nvSpPr>
            <p:spPr>
              <a:xfrm>
                <a:off x="1047669" y="4745920"/>
                <a:ext cx="377091" cy="207749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E917CAB0-F1BD-4BF3-FF03-B47E0E9E0315}"/>
                </a:ext>
              </a:extLst>
            </p:cNvPr>
            <p:cNvGrpSpPr/>
            <p:nvPr/>
          </p:nvGrpSpPr>
          <p:grpSpPr>
            <a:xfrm>
              <a:off x="766408" y="7471367"/>
              <a:ext cx="3465914" cy="2760136"/>
              <a:chOff x="766408" y="7471367"/>
              <a:chExt cx="3465914" cy="2760136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862AE0F3-6AE2-0703-9B0C-1D43BD5E87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06645" y="7471367"/>
                <a:ext cx="3025677" cy="2743200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87CF5BA-1255-4985-BD91-4AA2E5BB808B}"/>
                  </a:ext>
                </a:extLst>
              </p:cNvPr>
              <p:cNvSpPr txBox="1"/>
              <p:nvPr/>
            </p:nvSpPr>
            <p:spPr>
              <a:xfrm>
                <a:off x="1777941" y="9985282"/>
                <a:ext cx="207941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			diseased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B42AA2D-F38A-595C-230B-3B3B16DEE997}"/>
                  </a:ext>
                </a:extLst>
              </p:cNvPr>
              <p:cNvSpPr txBox="1"/>
              <p:nvPr/>
            </p:nvSpPr>
            <p:spPr>
              <a:xfrm rot="16200000">
                <a:off x="101483" y="8621728"/>
                <a:ext cx="157607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ensity of RPE (n/mm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 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627EC81-6998-22F2-340F-BAA8D8D0C67E}"/>
                  </a:ext>
                </a:extLst>
              </p:cNvPr>
              <p:cNvSpPr txBox="1"/>
              <p:nvPr/>
            </p:nvSpPr>
            <p:spPr>
              <a:xfrm>
                <a:off x="972662" y="7885404"/>
                <a:ext cx="441211" cy="189282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8000</a:t>
                </a: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7000</a:t>
                </a: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000</a:t>
                </a: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00</a:t>
                </a: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C35E1DC-5C44-05CD-F02B-7F49F9FF23B7}"/>
                </a:ext>
              </a:extLst>
            </p:cNvPr>
            <p:cNvSpPr txBox="1"/>
            <p:nvPr/>
          </p:nvSpPr>
          <p:spPr>
            <a:xfrm>
              <a:off x="619748" y="4244954"/>
              <a:ext cx="4431646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) Density of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yporeflective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regions in healthy and diseased retinas (n=1342; </a:t>
              </a:r>
              <a:r>
                <a:rPr lang="en-GB" altLang="en-CH" sz="10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ilcoxon non-parametric test, p=0.06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C1B738F-7BA6-D911-A99C-6BF8EA11F1D3}"/>
                </a:ext>
              </a:extLst>
            </p:cNvPr>
            <p:cNvSpPr txBox="1"/>
            <p:nvPr/>
          </p:nvSpPr>
          <p:spPr>
            <a:xfrm>
              <a:off x="619749" y="7390593"/>
              <a:ext cx="3612574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) RPE density in healthy and diseased retinas (n=390; </a:t>
              </a:r>
              <a:r>
                <a:rPr lang="en-GB" altLang="en-CH" sz="10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ilcoxon non-parametric test, p=0.1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737B7D4-11A7-B5B2-F2A3-22CF3124BE8D}"/>
                </a:ext>
              </a:extLst>
            </p:cNvPr>
            <p:cNvSpPr txBox="1"/>
            <p:nvPr/>
          </p:nvSpPr>
          <p:spPr>
            <a:xfrm>
              <a:off x="619748" y="1099316"/>
              <a:ext cx="4951973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) Density of hyperreflective regions in healthy and diseased retinas (n=1342; </a:t>
              </a:r>
              <a:r>
                <a:rPr lang="en-GB" altLang="en-CH" sz="10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ilcoxon non-parametric test, p&lt;0.001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47994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69563211-3A97-C99F-3DD0-D2400F9F3E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488" y="3811017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21">
            <a:extLst>
              <a:ext uri="{FF2B5EF4-FFF2-40B4-BE49-F238E27FC236}">
                <a16:creationId xmlns:a16="http://schemas.microsoft.com/office/drawing/2014/main" id="{B7533F4F-7FF4-3CA2-F068-845EEDBD25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518" y="2058933"/>
            <a:ext cx="5283200" cy="3263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165256B-2CBD-271D-F705-93BFABE9BE89}"/>
              </a:ext>
            </a:extLst>
          </p:cNvPr>
          <p:cNvSpPr txBox="1"/>
          <p:nvPr/>
        </p:nvSpPr>
        <p:spPr>
          <a:xfrm>
            <a:off x="612318" y="989208"/>
            <a:ext cx="495940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CH" altLang="en-CH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 RPE density according to image acquisition zone (n=339 images from 69 healthy eyes). </a:t>
            </a:r>
            <a:r>
              <a:rPr lang="en-GB" altLang="en-CH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 statistically significant difference in RPE cell count with increasing eccentricity (zones 1-4 vs. zone 5) was observable (two-sided ANOVA, p=0.69)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5761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075</TotalTime>
  <Words>181</Words>
  <Application>Microsoft Macintosh PowerPoint</Application>
  <PresentationFormat>Widescreen</PresentationFormat>
  <Paragraphs>5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ppenberger  Leila</dc:creator>
  <cp:lastModifiedBy>Leila Eppenberger</cp:lastModifiedBy>
  <cp:revision>192</cp:revision>
  <cp:lastPrinted>2023-07-10T13:52:50Z</cp:lastPrinted>
  <dcterms:created xsi:type="dcterms:W3CDTF">2023-07-09T18:33:52Z</dcterms:created>
  <dcterms:modified xsi:type="dcterms:W3CDTF">2025-08-24T20:04:36Z</dcterms:modified>
</cp:coreProperties>
</file>